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63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howGuides="1">
      <p:cViewPr varScale="1">
        <p:scale>
          <a:sx n="63" d="100"/>
          <a:sy n="63" d="100"/>
        </p:scale>
        <p:origin x="411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F2A523-E704-D585-50AF-80876A5BD7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E86C743-E881-A768-D12E-A9EA9BF74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2D6B21-0EE7-AC4E-AFF0-9D7C54A1B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E17E82-CD13-D1D0-36EC-86FCE2CC6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DF0E3B-CE68-026D-959E-87C318900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3992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270DF6-BCD8-67E2-FEF0-18A18B5BA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3C3F9AE-D6F3-FBFD-1DBC-E0E28802A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F1AA2C-391B-2908-21C5-2F4765381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3A61B8-83D8-5F61-BC5A-C1C79858B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067E3B-964B-4870-B55A-A8D832519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6858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F3E5EAA-7E66-97F0-CBAA-FE8CC230BE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B4CB5F-369E-7FD3-3BEB-0461CA6579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7D33AE-F49F-AB70-4553-6852B53FF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CFD93D-0589-0492-C33D-FF684293C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B6A614-AF47-0EA0-B1E5-D5BBAC156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8489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F56743-8984-B6A2-8E19-A8AECC8B0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133BFB6-25CD-B0D6-A37D-EC55390556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BA168A-4A63-03A8-6996-E11AD062A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AFA3A9-3DF2-2107-477C-FFABC5C06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E322B0-C908-B6EE-9569-482356955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787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8AD8A3-D558-294A-5BD8-D8EC6F142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3724DA-4C5C-3867-60B5-53B7D0FB4F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FFB815-70C7-1861-22E4-E87E4A808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C7DB3D-FBE1-F0E7-5DB9-787944637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5974D4-EEF5-BBE9-30D0-4CAE0C481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314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34059A-867D-61E8-90C1-CEE847D2A6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FD1CD9E-7ECB-E3B9-A940-74DE88BF1A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8F0A407-8938-4AAF-C805-0195BBB640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AE0880E-942A-C040-F6A4-10AB18BBB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82A11A-4320-8BE4-EEB6-C26048F05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C6D426-893D-633B-D76D-394648DA4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595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355149-CB65-FDD5-BF1F-C15EA6188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53299B-ED50-F674-29E8-79B30B8E93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C7D7DA-FE97-EAD4-B865-4224DF7D7E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C9BF6E-365B-A640-4C44-2ADD5DCAC8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BC8B07A-2083-471E-635C-4ECD787378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6D9C676-E7B8-83BF-458A-84B83DB02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3B5A04E-28CA-59B8-318A-B82504BB0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3FA9458-9770-27C8-F7FD-BB6FA759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4351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0C6BDD-8B61-EB52-5C69-7B9A97215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1A5C0BC-8080-6B03-E565-EFFEDCF71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F34CF73-8BA1-CEF4-962A-6B6949851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8D47F95-1942-F2F6-C9E3-B5030BE84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15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1CECE02-7DFD-7167-0A85-7A1379002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26D9A67-7240-9F0B-2DAD-E8242F5D5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A52481A-02FA-E5D4-4F54-915E5394A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44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0BBD1A-E4F5-C0FE-25FD-AD606795E6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5E6E41-2A86-4262-EDC2-57AA8943A5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00DCAC1-955F-3400-8A2D-9D5E49294F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4F94C6-CD9D-21DB-1A8E-AA1585F7D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A63B7FA-225E-9FBB-E054-55055D980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8AFBBC-111F-8B43-4872-3A1BA19BA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178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2F4694-CB22-0520-73F7-BA80394EB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335ECA-C9AF-DDA8-3F3B-4BCE8A69F7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93508F-E6A0-8636-0BDD-5DF2FFAE98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F472A57-5BAB-3E33-BF7D-CE55BBC11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FC5C0D-0925-08A6-0600-64E688607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745B70-2DCB-6A90-1F48-8C0A1F5AD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0703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B9E39AB-4195-9BF9-11FF-1CD3E2CB8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62B14F-3DB9-EB38-71CD-FAC22D175A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12320E-7070-BCC7-A4B0-A955A56E78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3D2EF-1F7C-4066-B009-64D740744824}" type="datetimeFigureOut">
              <a:rPr lang="zh-CN" altLang="en-US" smtClean="0"/>
              <a:t>2024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B5B8B7-CF60-90E6-3A85-8B7EA53C2B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EA8839-9B51-D403-833A-62922A4180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D65F9-9438-4EF9-8714-95C5313D67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8664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B1F0328-0608-F9B1-1137-C6B3059BC4A7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1756310"/>
            <a:ext cx="4075237" cy="283123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3F4BFC4-138E-2B67-A4EA-095EC508775A}"/>
              </a:ext>
            </a:extLst>
          </p:cNvPr>
          <p:cNvSpPr txBox="1"/>
          <p:nvPr/>
        </p:nvSpPr>
        <p:spPr>
          <a:xfrm>
            <a:off x="3054546" y="4928508"/>
            <a:ext cx="62681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 </a:t>
            </a:r>
            <a:r>
              <a:rPr lang="en-US" altLang="zh-C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plan-Meier curve of OS in patients who achieved PR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7C5CDE1-721E-E72D-F7C5-B738DBAA93B4}"/>
              </a:ext>
            </a:extLst>
          </p:cNvPr>
          <p:cNvSpPr txBox="1"/>
          <p:nvPr/>
        </p:nvSpPr>
        <p:spPr>
          <a:xfrm>
            <a:off x="5652577" y="1879718"/>
            <a:ext cx="10721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. S1</a:t>
            </a:r>
            <a:r>
              <a:rPr lang="zh-CN" altLang="zh-CN" sz="1400" b="1" dirty="0">
                <a:effectLst/>
                <a:ea typeface="Calibri" panose="020F0502020204030204" pitchFamily="34" charset="0"/>
              </a:rPr>
              <a:t> </a:t>
            </a:r>
            <a:endParaRPr lang="zh-CN" altLang="en-US" sz="14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9D8AA0D-C1D0-C05D-471D-EB8BA325B4CF}"/>
              </a:ext>
            </a:extLst>
          </p:cNvPr>
          <p:cNvSpPr txBox="1"/>
          <p:nvPr/>
        </p:nvSpPr>
        <p:spPr>
          <a:xfrm>
            <a:off x="2362200" y="5715000"/>
            <a:ext cx="79248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LEN, lenalidomide; MT, maintenance;</a:t>
            </a:r>
            <a:r>
              <a:rPr lang="zh-CN" altLang="en-US" sz="12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PFS, progression free survival; PR, partial remission; OS, overall survival; WBRT, whole brain radiation therapy</a:t>
            </a:r>
            <a:endParaRPr lang="zh-CN" altLang="zh-CN" sz="1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标题 4">
            <a:extLst>
              <a:ext uri="{FF2B5EF4-FFF2-40B4-BE49-F238E27FC236}">
                <a16:creationId xmlns:a16="http://schemas.microsoft.com/office/drawing/2014/main" id="{892049B1-880E-3204-F3A1-06A2DFE513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b="0" i="0" dirty="0">
                <a:solidFill>
                  <a:srgbClr val="222222"/>
                </a:solidFill>
                <a:effectLst/>
                <a:latin typeface="Merriweather" panose="00000500000000000000" pitchFamily="2" charset="0"/>
              </a:rPr>
              <a:t>Supplementary material-Fig.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09639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9A9E925D-230A-6EE6-601A-6E076B7D36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2897831"/>
              </p:ext>
            </p:extLst>
          </p:nvPr>
        </p:nvGraphicFramePr>
        <p:xfrm>
          <a:off x="1752600" y="1675448"/>
          <a:ext cx="8229600" cy="314020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01691">
                  <a:extLst>
                    <a:ext uri="{9D8B030D-6E8A-4147-A177-3AD203B41FA5}">
                      <a16:colId xmlns:a16="http://schemas.microsoft.com/office/drawing/2014/main" val="3871609180"/>
                    </a:ext>
                  </a:extLst>
                </a:gridCol>
                <a:gridCol w="6827909">
                  <a:extLst>
                    <a:ext uri="{9D8B030D-6E8A-4147-A177-3AD203B41FA5}">
                      <a16:colId xmlns:a16="http://schemas.microsoft.com/office/drawing/2014/main" val="2056285086"/>
                    </a:ext>
                  </a:extLst>
                </a:gridCol>
              </a:tblGrid>
              <a:tr h="208344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gimen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Medications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0744514"/>
                  </a:ext>
                </a:extLst>
              </a:tr>
              <a:tr h="416687">
                <a:tc>
                  <a:txBody>
                    <a:bodyPr/>
                    <a:lstStyle/>
                    <a:p>
                      <a:pPr algn="l"/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HD-MTX±R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Methotrexate 5.0 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with or without rituximab 375m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for 8 cycles every 14 days per cycle. 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16096735"/>
                  </a:ext>
                </a:extLst>
              </a:tr>
              <a:tr h="625031">
                <a:tc>
                  <a:txBody>
                    <a:bodyPr/>
                    <a:lstStyle/>
                    <a:p>
                      <a:pPr algn="l"/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R-MA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ituximab 375 m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, methotrexate 3.5 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on day 1, and cytarabine 2.0 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twice daily on days 2 and 3 for 6 cycles every 28 days per cycle.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1809478"/>
                  </a:ext>
                </a:extLst>
              </a:tr>
              <a:tr h="625031">
                <a:tc>
                  <a:txBody>
                    <a:bodyPr/>
                    <a:lstStyle/>
                    <a:p>
                      <a:pPr algn="l"/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R</a:t>
                      </a:r>
                      <a:r>
                        <a:rPr lang="en-US" sz="1400" kern="100" baseline="30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-MTX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ituximab 375 m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and lenalidomide 25 mg from days 1 to 14 and methotrexate 3.5 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on day 1 for 6 cycles every 21 days per cycle.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6624621"/>
                  </a:ext>
                </a:extLst>
              </a:tr>
              <a:tr h="1250060">
                <a:tc>
                  <a:txBody>
                    <a:bodyPr/>
                    <a:lstStyle/>
                    <a:p>
                      <a:pPr algn="l"/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AB ± R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Course A: Methotrexate 3 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 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on day 1, ifosfamide 800 m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on days 2–4, vindesine 4 mg on day 1, and dexamethasone 10 mg/m</a:t>
                      </a:r>
                      <a:r>
                        <a:rPr lang="en-US" sz="1400" kern="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days 2–4. 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Course B: </a:t>
                      </a: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Carmustine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125 mg on day 1, </a:t>
                      </a: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teniposide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50 mg on days 1–3, vindesine 4 mg on day 1, and dexamethasone 10 mg on days 2–4 for 4 cycles every 28 days per cycle (course A+B). 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4494136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4FB6BF60-DE55-849E-41F8-1D934A293B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6332" y="5562600"/>
            <a:ext cx="368722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>
                <a:ln>
                  <a:noFill/>
                </a:ln>
                <a:effectLst/>
                <a:latin typeface="等线" panose="02010600030101010101" pitchFamily="2" charset="-122"/>
                <a:ea typeface="Calibri" panose="020F0502020204030204" pitchFamily="34" charset="0"/>
                <a:cs typeface="Times New Roman" panose="02020603050405020304" pitchFamily="18" charset="0"/>
              </a:rPr>
              <a:t>Table S1: Methotrexate-based induction regimens</a:t>
            </a:r>
            <a:endParaRPr kumimoji="0" lang="en-US" altLang="zh-CN" sz="6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8" name="标题 7">
            <a:extLst>
              <a:ext uri="{FF2B5EF4-FFF2-40B4-BE49-F238E27FC236}">
                <a16:creationId xmlns:a16="http://schemas.microsoft.com/office/drawing/2014/main" id="{59FD2E8F-DE07-7CD6-98C2-B48281616B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b="0" i="0" dirty="0">
                <a:effectLst/>
                <a:latin typeface="Merriweather" panose="00000500000000000000" pitchFamily="2" charset="0"/>
              </a:rPr>
              <a:t>Supplementary material-Table.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29120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168928-55A6-296E-6464-BE04BB3C25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b="0" i="0" dirty="0">
                <a:effectLst/>
                <a:latin typeface="Merriweather" panose="00000500000000000000" pitchFamily="2" charset="0"/>
              </a:rPr>
              <a:t>Supplementary material-Table</a:t>
            </a:r>
            <a:r>
              <a:rPr lang="en-US" altLang="zh-CN" dirty="0">
                <a:latin typeface="Merriweather" panose="00000500000000000000" pitchFamily="2" charset="0"/>
              </a:rPr>
              <a:t>.</a:t>
            </a:r>
            <a:r>
              <a:rPr lang="en-US" altLang="zh-CN" b="0" i="0" dirty="0">
                <a:effectLst/>
                <a:latin typeface="Merriweather" panose="00000500000000000000" pitchFamily="2" charset="0"/>
              </a:rPr>
              <a:t>S2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2CD18F41-4E86-6AAF-37BE-72E4432678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6087214"/>
              </p:ext>
            </p:extLst>
          </p:nvPr>
        </p:nvGraphicFramePr>
        <p:xfrm>
          <a:off x="990600" y="2133600"/>
          <a:ext cx="10210800" cy="228901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164390">
                  <a:extLst>
                    <a:ext uri="{9D8B030D-6E8A-4147-A177-3AD203B41FA5}">
                      <a16:colId xmlns:a16="http://schemas.microsoft.com/office/drawing/2014/main" val="30826842"/>
                    </a:ext>
                  </a:extLst>
                </a:gridCol>
                <a:gridCol w="1602472">
                  <a:extLst>
                    <a:ext uri="{9D8B030D-6E8A-4147-A177-3AD203B41FA5}">
                      <a16:colId xmlns:a16="http://schemas.microsoft.com/office/drawing/2014/main" val="1677068327"/>
                    </a:ext>
                  </a:extLst>
                </a:gridCol>
                <a:gridCol w="2590856">
                  <a:extLst>
                    <a:ext uri="{9D8B030D-6E8A-4147-A177-3AD203B41FA5}">
                      <a16:colId xmlns:a16="http://schemas.microsoft.com/office/drawing/2014/main" val="1929188362"/>
                    </a:ext>
                  </a:extLst>
                </a:gridCol>
                <a:gridCol w="2432079">
                  <a:extLst>
                    <a:ext uri="{9D8B030D-6E8A-4147-A177-3AD203B41FA5}">
                      <a16:colId xmlns:a16="http://schemas.microsoft.com/office/drawing/2014/main" val="2359628650"/>
                    </a:ext>
                  </a:extLst>
                </a:gridCol>
                <a:gridCol w="2421003">
                  <a:extLst>
                    <a:ext uri="{9D8B030D-6E8A-4147-A177-3AD203B41FA5}">
                      <a16:colId xmlns:a16="http://schemas.microsoft.com/office/drawing/2014/main" val="3312563775"/>
                    </a:ext>
                  </a:extLst>
                </a:gridCol>
              </a:tblGrid>
              <a:tr h="457803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Visit time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Case number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Global health score </a:t>
                      </a:r>
                    </a:p>
                    <a:p>
                      <a:pPr algn="ctr"/>
                      <a:r>
                        <a:rPr lang="en-US" sz="1400" kern="100" dirty="0">
                          <a:effectLst/>
                        </a:rPr>
                        <a:t>(range, 1–7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Function score </a:t>
                      </a:r>
                    </a:p>
                    <a:p>
                      <a:pPr algn="ctr"/>
                      <a:r>
                        <a:rPr lang="en-US" sz="1400" kern="100" dirty="0">
                          <a:effectLst/>
                        </a:rPr>
                        <a:t>(range, 5–20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Symptom score</a:t>
                      </a:r>
                    </a:p>
                    <a:p>
                      <a:pPr algn="ctr"/>
                      <a:r>
                        <a:rPr lang="en-US" sz="1400" kern="100" dirty="0">
                          <a:effectLst/>
                        </a:rPr>
                        <a:t> (range, 9–36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99499643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Baseline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7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2.23±0.88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15.04±3.39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4.53±2.83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66850991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EOT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17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3.82±1.10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9.59±2.77 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12.38±2.49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6277572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6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7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12±0.76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7.70±1.70 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10.26±1.08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52280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9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7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47±0.92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7.21±1.47 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9.87±0.79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6817915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12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3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69±0.91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6.97±1.66 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9.73±0.79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4928559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15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7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42±0.73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7.62±1.26 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9.81±0.67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09535985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18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6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67±0.75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7.75±1.50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10.14±1.05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79572963"/>
                  </a:ext>
                </a:extLst>
              </a:tr>
              <a:tr h="228902"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M24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5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5.60±0.80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>
                          <a:effectLst/>
                        </a:rPr>
                        <a:t>7.22±1.15 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effectLst/>
                        </a:rPr>
                        <a:t>9.87±0.68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8521015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39C8B648-A599-50C6-0808-A29921DFA382}"/>
              </a:ext>
            </a:extLst>
          </p:cNvPr>
          <p:cNvSpPr txBox="1"/>
          <p:nvPr/>
        </p:nvSpPr>
        <p:spPr>
          <a:xfrm>
            <a:off x="3048000" y="451905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able S2: Quality of life assessment during treatment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3E79E49-8AD7-04F1-BABA-E26B20232182}"/>
              </a:ext>
            </a:extLst>
          </p:cNvPr>
          <p:cNvSpPr txBox="1"/>
          <p:nvPr/>
        </p:nvSpPr>
        <p:spPr>
          <a:xfrm>
            <a:off x="2590800" y="5257800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l"/>
            <a:r>
              <a:rPr lang="en-US" altLang="zh-CN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OT, end of treatment; M, month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7242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335</Words>
  <Application>Microsoft Office PowerPoint</Application>
  <PresentationFormat>宽屏</PresentationFormat>
  <Paragraphs>7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Merriweather</vt:lpstr>
      <vt:lpstr>Office 主题​​</vt:lpstr>
      <vt:lpstr>Supplementary material-Fig.S1</vt:lpstr>
      <vt:lpstr>Supplementary material-Table.S1</vt:lpstr>
      <vt:lpstr>Supplementary material-Table.S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-Fig.S1</dc:title>
  <dc:creator>张 炎</dc:creator>
  <cp:lastModifiedBy>炎 张</cp:lastModifiedBy>
  <cp:revision>4</cp:revision>
  <dcterms:created xsi:type="dcterms:W3CDTF">2023-06-09T07:04:31Z</dcterms:created>
  <dcterms:modified xsi:type="dcterms:W3CDTF">2024-03-18T09:17:00Z</dcterms:modified>
</cp:coreProperties>
</file>